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sldIdLst>
    <p:sldId id="256" r:id="rId2"/>
  </p:sldIdLst>
  <p:sldSz cx="9783763" cy="23780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0" d="100"/>
          <a:sy n="90" d="100"/>
        </p:scale>
        <p:origin x="1051" y="1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22971" y="389190"/>
            <a:ext cx="7337822" cy="827922"/>
          </a:xfrm>
        </p:spPr>
        <p:txBody>
          <a:bodyPr anchor="b"/>
          <a:lstStyle>
            <a:lvl1pPr algn="ctr">
              <a:defRPr sz="20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22971" y="1249040"/>
            <a:ext cx="7337822" cy="574151"/>
          </a:xfrm>
        </p:spPr>
        <p:txBody>
          <a:bodyPr/>
          <a:lstStyle>
            <a:lvl1pPr marL="0" indent="0" algn="ctr">
              <a:buNone/>
              <a:defRPr sz="832"/>
            </a:lvl1pPr>
            <a:lvl2pPr marL="158557" indent="0" algn="ctr">
              <a:buNone/>
              <a:defRPr sz="694"/>
            </a:lvl2pPr>
            <a:lvl3pPr marL="317114" indent="0" algn="ctr">
              <a:buNone/>
              <a:defRPr sz="624"/>
            </a:lvl3pPr>
            <a:lvl4pPr marL="475671" indent="0" algn="ctr">
              <a:buNone/>
              <a:defRPr sz="555"/>
            </a:lvl4pPr>
            <a:lvl5pPr marL="634228" indent="0" algn="ctr">
              <a:buNone/>
              <a:defRPr sz="555"/>
            </a:lvl5pPr>
            <a:lvl6pPr marL="792785" indent="0" algn="ctr">
              <a:buNone/>
              <a:defRPr sz="555"/>
            </a:lvl6pPr>
            <a:lvl7pPr marL="951342" indent="0" algn="ctr">
              <a:buNone/>
              <a:defRPr sz="555"/>
            </a:lvl7pPr>
            <a:lvl8pPr marL="1109899" indent="0" algn="ctr">
              <a:buNone/>
              <a:defRPr sz="555"/>
            </a:lvl8pPr>
            <a:lvl9pPr marL="1268456" indent="0" algn="ctr">
              <a:buNone/>
              <a:defRPr sz="55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384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9042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01505" y="126610"/>
            <a:ext cx="2109624" cy="20153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72634" y="126610"/>
            <a:ext cx="6206575" cy="201530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773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402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7538" y="592868"/>
            <a:ext cx="8438496" cy="989213"/>
          </a:xfrm>
        </p:spPr>
        <p:txBody>
          <a:bodyPr anchor="b"/>
          <a:lstStyle>
            <a:lvl1pPr>
              <a:defRPr sz="20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7538" y="1591439"/>
            <a:ext cx="8438496" cy="520204"/>
          </a:xfrm>
        </p:spPr>
        <p:txBody>
          <a:bodyPr/>
          <a:lstStyle>
            <a:lvl1pPr marL="0" indent="0">
              <a:buNone/>
              <a:defRPr sz="832">
                <a:solidFill>
                  <a:schemeClr val="tx1">
                    <a:tint val="75000"/>
                  </a:schemeClr>
                </a:solidFill>
              </a:defRPr>
            </a:lvl1pPr>
            <a:lvl2pPr marL="158557" indent="0">
              <a:buNone/>
              <a:defRPr sz="694">
                <a:solidFill>
                  <a:schemeClr val="tx1">
                    <a:tint val="75000"/>
                  </a:schemeClr>
                </a:solidFill>
              </a:defRPr>
            </a:lvl2pPr>
            <a:lvl3pPr marL="317114" indent="0">
              <a:buNone/>
              <a:defRPr sz="624">
                <a:solidFill>
                  <a:schemeClr val="tx1">
                    <a:tint val="75000"/>
                  </a:schemeClr>
                </a:solidFill>
              </a:defRPr>
            </a:lvl3pPr>
            <a:lvl4pPr marL="475671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4pPr>
            <a:lvl5pPr marL="634228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5pPr>
            <a:lvl6pPr marL="792785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6pPr>
            <a:lvl7pPr marL="951342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7pPr>
            <a:lvl8pPr marL="1109899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8pPr>
            <a:lvl9pPr marL="1268456" indent="0">
              <a:buNone/>
              <a:defRPr sz="55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0450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72634" y="633052"/>
            <a:ext cx="4158099" cy="15088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30" y="633052"/>
            <a:ext cx="4158099" cy="15088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014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3908" y="126611"/>
            <a:ext cx="8438496" cy="45965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3908" y="582959"/>
            <a:ext cx="4138990" cy="285699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557" indent="0">
              <a:buNone/>
              <a:defRPr sz="694" b="1"/>
            </a:lvl2pPr>
            <a:lvl3pPr marL="317114" indent="0">
              <a:buNone/>
              <a:defRPr sz="624" b="1"/>
            </a:lvl3pPr>
            <a:lvl4pPr marL="475671" indent="0">
              <a:buNone/>
              <a:defRPr sz="555" b="1"/>
            </a:lvl4pPr>
            <a:lvl5pPr marL="634228" indent="0">
              <a:buNone/>
              <a:defRPr sz="555" b="1"/>
            </a:lvl5pPr>
            <a:lvl6pPr marL="792785" indent="0">
              <a:buNone/>
              <a:defRPr sz="555" b="1"/>
            </a:lvl6pPr>
            <a:lvl7pPr marL="951342" indent="0">
              <a:buNone/>
              <a:defRPr sz="555" b="1"/>
            </a:lvl7pPr>
            <a:lvl8pPr marL="1109899" indent="0">
              <a:buNone/>
              <a:defRPr sz="555" b="1"/>
            </a:lvl8pPr>
            <a:lvl9pPr marL="1268456" indent="0">
              <a:buNone/>
              <a:defRPr sz="555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3908" y="868658"/>
            <a:ext cx="4138990" cy="12776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953030" y="582959"/>
            <a:ext cx="4159374" cy="285699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557" indent="0">
              <a:buNone/>
              <a:defRPr sz="694" b="1"/>
            </a:lvl2pPr>
            <a:lvl3pPr marL="317114" indent="0">
              <a:buNone/>
              <a:defRPr sz="624" b="1"/>
            </a:lvl3pPr>
            <a:lvl4pPr marL="475671" indent="0">
              <a:buNone/>
              <a:defRPr sz="555" b="1"/>
            </a:lvl4pPr>
            <a:lvl5pPr marL="634228" indent="0">
              <a:buNone/>
              <a:defRPr sz="555" b="1"/>
            </a:lvl5pPr>
            <a:lvl6pPr marL="792785" indent="0">
              <a:buNone/>
              <a:defRPr sz="555" b="1"/>
            </a:lvl6pPr>
            <a:lvl7pPr marL="951342" indent="0">
              <a:buNone/>
              <a:defRPr sz="555" b="1"/>
            </a:lvl7pPr>
            <a:lvl8pPr marL="1109899" indent="0">
              <a:buNone/>
              <a:defRPr sz="555" b="1"/>
            </a:lvl8pPr>
            <a:lvl9pPr marL="1268456" indent="0">
              <a:buNone/>
              <a:defRPr sz="555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953030" y="868658"/>
            <a:ext cx="4159374" cy="1277665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834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7740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62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3908" y="158538"/>
            <a:ext cx="3155518" cy="554884"/>
          </a:xfrm>
        </p:spPr>
        <p:txBody>
          <a:bodyPr anchor="b"/>
          <a:lstStyle>
            <a:lvl1pPr>
              <a:defRPr sz="111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159374" y="342399"/>
            <a:ext cx="4953030" cy="1689975"/>
          </a:xfrm>
        </p:spPr>
        <p:txBody>
          <a:bodyPr/>
          <a:lstStyle>
            <a:lvl1pPr>
              <a:defRPr sz="1110"/>
            </a:lvl1pPr>
            <a:lvl2pPr>
              <a:defRPr sz="971"/>
            </a:lvl2pPr>
            <a:lvl3pPr>
              <a:defRPr sz="832"/>
            </a:lvl3pPr>
            <a:lvl4pPr>
              <a:defRPr sz="694"/>
            </a:lvl4pPr>
            <a:lvl5pPr>
              <a:defRPr sz="694"/>
            </a:lvl5pPr>
            <a:lvl6pPr>
              <a:defRPr sz="694"/>
            </a:lvl6pPr>
            <a:lvl7pPr>
              <a:defRPr sz="694"/>
            </a:lvl7pPr>
            <a:lvl8pPr>
              <a:defRPr sz="694"/>
            </a:lvl8pPr>
            <a:lvl9pPr>
              <a:defRPr sz="69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3908" y="713423"/>
            <a:ext cx="3155518" cy="1321703"/>
          </a:xfrm>
        </p:spPr>
        <p:txBody>
          <a:bodyPr/>
          <a:lstStyle>
            <a:lvl1pPr marL="0" indent="0">
              <a:buNone/>
              <a:defRPr sz="555"/>
            </a:lvl1pPr>
            <a:lvl2pPr marL="158557" indent="0">
              <a:buNone/>
              <a:defRPr sz="486"/>
            </a:lvl2pPr>
            <a:lvl3pPr marL="317114" indent="0">
              <a:buNone/>
              <a:defRPr sz="416"/>
            </a:lvl3pPr>
            <a:lvl4pPr marL="475671" indent="0">
              <a:buNone/>
              <a:defRPr sz="347"/>
            </a:lvl4pPr>
            <a:lvl5pPr marL="634228" indent="0">
              <a:buNone/>
              <a:defRPr sz="347"/>
            </a:lvl5pPr>
            <a:lvl6pPr marL="792785" indent="0">
              <a:buNone/>
              <a:defRPr sz="347"/>
            </a:lvl6pPr>
            <a:lvl7pPr marL="951342" indent="0">
              <a:buNone/>
              <a:defRPr sz="347"/>
            </a:lvl7pPr>
            <a:lvl8pPr marL="1109899" indent="0">
              <a:buNone/>
              <a:defRPr sz="347"/>
            </a:lvl8pPr>
            <a:lvl9pPr marL="1268456" indent="0">
              <a:buNone/>
              <a:defRPr sz="34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016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3908" y="158538"/>
            <a:ext cx="3155518" cy="554884"/>
          </a:xfrm>
        </p:spPr>
        <p:txBody>
          <a:bodyPr anchor="b"/>
          <a:lstStyle>
            <a:lvl1pPr>
              <a:defRPr sz="111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59374" y="342399"/>
            <a:ext cx="4953030" cy="1689975"/>
          </a:xfrm>
        </p:spPr>
        <p:txBody>
          <a:bodyPr anchor="t"/>
          <a:lstStyle>
            <a:lvl1pPr marL="0" indent="0">
              <a:buNone/>
              <a:defRPr sz="1110"/>
            </a:lvl1pPr>
            <a:lvl2pPr marL="158557" indent="0">
              <a:buNone/>
              <a:defRPr sz="971"/>
            </a:lvl2pPr>
            <a:lvl3pPr marL="317114" indent="0">
              <a:buNone/>
              <a:defRPr sz="832"/>
            </a:lvl3pPr>
            <a:lvl4pPr marL="475671" indent="0">
              <a:buNone/>
              <a:defRPr sz="694"/>
            </a:lvl4pPr>
            <a:lvl5pPr marL="634228" indent="0">
              <a:buNone/>
              <a:defRPr sz="694"/>
            </a:lvl5pPr>
            <a:lvl6pPr marL="792785" indent="0">
              <a:buNone/>
              <a:defRPr sz="694"/>
            </a:lvl6pPr>
            <a:lvl7pPr marL="951342" indent="0">
              <a:buNone/>
              <a:defRPr sz="694"/>
            </a:lvl7pPr>
            <a:lvl8pPr marL="1109899" indent="0">
              <a:buNone/>
              <a:defRPr sz="694"/>
            </a:lvl8pPr>
            <a:lvl9pPr marL="1268456" indent="0">
              <a:buNone/>
              <a:defRPr sz="69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73908" y="713423"/>
            <a:ext cx="3155518" cy="1321703"/>
          </a:xfrm>
        </p:spPr>
        <p:txBody>
          <a:bodyPr/>
          <a:lstStyle>
            <a:lvl1pPr marL="0" indent="0">
              <a:buNone/>
              <a:defRPr sz="555"/>
            </a:lvl1pPr>
            <a:lvl2pPr marL="158557" indent="0">
              <a:buNone/>
              <a:defRPr sz="486"/>
            </a:lvl2pPr>
            <a:lvl3pPr marL="317114" indent="0">
              <a:buNone/>
              <a:defRPr sz="416"/>
            </a:lvl3pPr>
            <a:lvl4pPr marL="475671" indent="0">
              <a:buNone/>
              <a:defRPr sz="347"/>
            </a:lvl4pPr>
            <a:lvl5pPr marL="634228" indent="0">
              <a:buNone/>
              <a:defRPr sz="347"/>
            </a:lvl5pPr>
            <a:lvl6pPr marL="792785" indent="0">
              <a:buNone/>
              <a:defRPr sz="347"/>
            </a:lvl6pPr>
            <a:lvl7pPr marL="951342" indent="0">
              <a:buNone/>
              <a:defRPr sz="347"/>
            </a:lvl7pPr>
            <a:lvl8pPr marL="1109899" indent="0">
              <a:buNone/>
              <a:defRPr sz="347"/>
            </a:lvl8pPr>
            <a:lvl9pPr marL="1268456" indent="0">
              <a:buNone/>
              <a:defRPr sz="34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339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72634" y="126611"/>
            <a:ext cx="8438496" cy="4596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2634" y="633052"/>
            <a:ext cx="8438496" cy="150886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72634" y="2204124"/>
            <a:ext cx="2201347" cy="1266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1EB053-0190-4627-A2D3-DD0726A160D8}" type="datetimeFigureOut">
              <a:rPr lang="en-US" smtClean="0"/>
              <a:t>8/1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40872" y="2204124"/>
            <a:ext cx="3302020" cy="1266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09782" y="2204124"/>
            <a:ext cx="2201347" cy="1266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C866D6-0627-459D-8076-F93D2C6F11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40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317114" rtl="0" eaLnBrk="1" latinLnBrk="0" hangingPunct="1">
        <a:lnSpc>
          <a:spcPct val="90000"/>
        </a:lnSpc>
        <a:spcBef>
          <a:spcPct val="0"/>
        </a:spcBef>
        <a:buNone/>
        <a:defRPr sz="152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9278" indent="-79278" algn="l" defTabSz="317114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971" kern="1200">
          <a:solidFill>
            <a:schemeClr val="tx1"/>
          </a:solidFill>
          <a:latin typeface="+mn-lt"/>
          <a:ea typeface="+mn-ea"/>
          <a:cs typeface="+mn-cs"/>
        </a:defRPr>
      </a:lvl1pPr>
      <a:lvl2pPr marL="237835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832" kern="1200">
          <a:solidFill>
            <a:schemeClr val="tx1"/>
          </a:solidFill>
          <a:latin typeface="+mn-lt"/>
          <a:ea typeface="+mn-ea"/>
          <a:cs typeface="+mn-cs"/>
        </a:defRPr>
      </a:lvl2pPr>
      <a:lvl3pPr marL="396392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94" kern="1200">
          <a:solidFill>
            <a:schemeClr val="tx1"/>
          </a:solidFill>
          <a:latin typeface="+mn-lt"/>
          <a:ea typeface="+mn-ea"/>
          <a:cs typeface="+mn-cs"/>
        </a:defRPr>
      </a:lvl3pPr>
      <a:lvl4pPr marL="554949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713506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872063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1030620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89177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347734" indent="-79278" algn="l" defTabSz="317114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1pPr>
      <a:lvl2pPr marL="158557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2pPr>
      <a:lvl3pPr marL="317114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3pPr>
      <a:lvl4pPr marL="475671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634228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792785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951342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09899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268456" algn="l" defTabSz="317114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97CA694-E268-46FF-8D8E-B1BE46AAAA4E}"/>
              </a:ext>
            </a:extLst>
          </p:cNvPr>
          <p:cNvGrpSpPr/>
          <p:nvPr/>
        </p:nvGrpSpPr>
        <p:grpSpPr>
          <a:xfrm>
            <a:off x="128692" y="254496"/>
            <a:ext cx="716438" cy="891165"/>
            <a:chOff x="2616779" y="1602814"/>
            <a:chExt cx="716438" cy="891165"/>
          </a:xfrm>
        </p:grpSpPr>
        <p:sp>
          <p:nvSpPr>
            <p:cNvPr id="3" name="Flowchart: Magnetic Disk 2">
              <a:extLst>
                <a:ext uri="{FF2B5EF4-FFF2-40B4-BE49-F238E27FC236}">
                  <a16:creationId xmlns:a16="http://schemas.microsoft.com/office/drawing/2014/main" id="{5E3822D8-4A7B-4A7F-B6AE-D354911D9A2A}"/>
                </a:ext>
              </a:extLst>
            </p:cNvPr>
            <p:cNvSpPr/>
            <p:nvPr/>
          </p:nvSpPr>
          <p:spPr>
            <a:xfrm>
              <a:off x="2616779" y="1602814"/>
              <a:ext cx="716438" cy="891165"/>
            </a:xfrm>
            <a:prstGeom prst="flowChartMagneticDisk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8ED3C84-D436-4026-9D23-03FF3F90D8C3}"/>
                </a:ext>
              </a:extLst>
            </p:cNvPr>
            <p:cNvSpPr txBox="1"/>
            <p:nvPr/>
          </p:nvSpPr>
          <p:spPr>
            <a:xfrm>
              <a:off x="2654487" y="1882217"/>
              <a:ext cx="66761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witter 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set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280C970B-B18C-45C5-BCC1-3C471CC7DB1E}"/>
              </a:ext>
            </a:extLst>
          </p:cNvPr>
          <p:cNvGrpSpPr/>
          <p:nvPr/>
        </p:nvGrpSpPr>
        <p:grpSpPr>
          <a:xfrm>
            <a:off x="2975593" y="917286"/>
            <a:ext cx="1583827" cy="632314"/>
            <a:chOff x="3729627" y="1764503"/>
            <a:chExt cx="1583827" cy="632314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BBB05874-8748-41E2-907D-A8CD8313BFAD}"/>
                </a:ext>
              </a:extLst>
            </p:cNvPr>
            <p:cNvSpPr/>
            <p:nvPr/>
          </p:nvSpPr>
          <p:spPr>
            <a:xfrm>
              <a:off x="3830227" y="1764503"/>
              <a:ext cx="1377017" cy="632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325FA4F-3196-4807-B1B6-EFEAB70C148E}"/>
                </a:ext>
              </a:extLst>
            </p:cNvPr>
            <p:cNvSpPr txBox="1"/>
            <p:nvPr/>
          </p:nvSpPr>
          <p:spPr>
            <a:xfrm>
              <a:off x="3729627" y="1882217"/>
              <a:ext cx="158382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lecting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p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aintainers’ Tweets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93DDE80-1F51-4EBC-94BC-1E8488A94112}"/>
              </a:ext>
            </a:extLst>
          </p:cNvPr>
          <p:cNvGrpSpPr/>
          <p:nvPr/>
        </p:nvGrpSpPr>
        <p:grpSpPr>
          <a:xfrm>
            <a:off x="4666449" y="917286"/>
            <a:ext cx="1704551" cy="632314"/>
            <a:chOff x="5448693" y="1764503"/>
            <a:chExt cx="1704551" cy="632314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332455E-B50D-4B92-B31E-0EDD0D18C8F4}"/>
                </a:ext>
              </a:extLst>
            </p:cNvPr>
            <p:cNvSpPr/>
            <p:nvPr/>
          </p:nvSpPr>
          <p:spPr>
            <a:xfrm>
              <a:off x="5569417" y="1764503"/>
              <a:ext cx="1497759" cy="632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C918D27-C141-4721-9DA9-C125C7477FCF}"/>
                </a:ext>
              </a:extLst>
            </p:cNvPr>
            <p:cNvSpPr txBox="1"/>
            <p:nvPr/>
          </p:nvSpPr>
          <p:spPr>
            <a:xfrm>
              <a:off x="5448693" y="1882217"/>
              <a:ext cx="17045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Identifying Tweet topic, nature and sentiment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EAA6010-0DFA-4065-B8B8-3265E996B287}"/>
              </a:ext>
            </a:extLst>
          </p:cNvPr>
          <p:cNvGrpSpPr/>
          <p:nvPr/>
        </p:nvGrpSpPr>
        <p:grpSpPr>
          <a:xfrm>
            <a:off x="6315249" y="917286"/>
            <a:ext cx="2290074" cy="632314"/>
            <a:chOff x="6870555" y="1764503"/>
            <a:chExt cx="2290074" cy="632314"/>
          </a:xfrm>
        </p:grpSpPr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0EE86D84-B009-4435-A269-524DED2F2062}"/>
                </a:ext>
              </a:extLst>
            </p:cNvPr>
            <p:cNvSpPr/>
            <p:nvPr/>
          </p:nvSpPr>
          <p:spPr>
            <a:xfrm>
              <a:off x="7153245" y="1764503"/>
              <a:ext cx="1770004" cy="632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4CC1241-A04F-4089-9697-A75085919918}"/>
                </a:ext>
              </a:extLst>
            </p:cNvPr>
            <p:cNvSpPr txBox="1"/>
            <p:nvPr/>
          </p:nvSpPr>
          <p:spPr>
            <a:xfrm>
              <a:off x="6870555" y="1882217"/>
              <a:ext cx="229007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appa Agreement checking 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Tweet categorization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id="{9BA0CE4A-D82D-487C-B6CE-5D8A60CAD53B}"/>
              </a:ext>
            </a:extLst>
          </p:cNvPr>
          <p:cNvGrpSpPr/>
          <p:nvPr/>
        </p:nvGrpSpPr>
        <p:grpSpPr>
          <a:xfrm>
            <a:off x="8490097" y="820129"/>
            <a:ext cx="1340740" cy="891165"/>
            <a:chOff x="8857796" y="1667342"/>
            <a:chExt cx="1340740" cy="891165"/>
          </a:xfrm>
        </p:grpSpPr>
        <p:sp>
          <p:nvSpPr>
            <p:cNvPr id="23" name="Flowchart: Multidocument 22">
              <a:extLst>
                <a:ext uri="{FF2B5EF4-FFF2-40B4-BE49-F238E27FC236}">
                  <a16:creationId xmlns:a16="http://schemas.microsoft.com/office/drawing/2014/main" id="{F1A02627-2314-4C1F-B38D-B6C455D61B1D}"/>
                </a:ext>
              </a:extLst>
            </p:cNvPr>
            <p:cNvSpPr/>
            <p:nvPr/>
          </p:nvSpPr>
          <p:spPr>
            <a:xfrm>
              <a:off x="9044869" y="1667342"/>
              <a:ext cx="1060704" cy="891165"/>
            </a:xfrm>
            <a:prstGeom prst="flowChartMultidocumen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09442C5-1204-4EA2-85BF-C44E05A11206}"/>
                </a:ext>
              </a:extLst>
            </p:cNvPr>
            <p:cNvSpPr txBox="1"/>
            <p:nvPr/>
          </p:nvSpPr>
          <p:spPr>
            <a:xfrm>
              <a:off x="8857796" y="1812859"/>
              <a:ext cx="134074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ults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ategorized </a:t>
              </a:r>
            </a:p>
            <a:p>
              <a:pPr algn="ctr"/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p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Tweets)</a:t>
              </a:r>
            </a:p>
          </p:txBody>
        </p:sp>
      </p:grp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47024630-2479-4490-9E38-7D7221188EBE}"/>
              </a:ext>
            </a:extLst>
          </p:cNvPr>
          <p:cNvCxnSpPr/>
          <p:nvPr/>
        </p:nvCxnSpPr>
        <p:spPr>
          <a:xfrm>
            <a:off x="2763179" y="1207827"/>
            <a:ext cx="3130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D180DF0-108A-4CE9-A240-97E4EF5FAE14}"/>
              </a:ext>
            </a:extLst>
          </p:cNvPr>
          <p:cNvCxnSpPr/>
          <p:nvPr/>
        </p:nvCxnSpPr>
        <p:spPr>
          <a:xfrm>
            <a:off x="4458044" y="1209399"/>
            <a:ext cx="3130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9A7D4F54-8085-4D63-AF64-0A64D1D0CCCC}"/>
              </a:ext>
            </a:extLst>
          </p:cNvPr>
          <p:cNvCxnSpPr/>
          <p:nvPr/>
        </p:nvCxnSpPr>
        <p:spPr>
          <a:xfrm>
            <a:off x="6279699" y="1220398"/>
            <a:ext cx="3130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A154FC2-FE22-4872-BE6F-F15A2F616848}"/>
              </a:ext>
            </a:extLst>
          </p:cNvPr>
          <p:cNvCxnSpPr/>
          <p:nvPr/>
        </p:nvCxnSpPr>
        <p:spPr>
          <a:xfrm>
            <a:off x="8355476" y="1232969"/>
            <a:ext cx="31301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6" name="Picture 35">
            <a:extLst>
              <a:ext uri="{FF2B5EF4-FFF2-40B4-BE49-F238E27FC236}">
                <a16:creationId xmlns:a16="http://schemas.microsoft.com/office/drawing/2014/main" id="{486B8B1B-D8C8-46BE-891D-B4173B839B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0574" y="597269"/>
            <a:ext cx="398456" cy="4997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8123055-38A3-494F-9003-C4FCD94CD0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48547" y="597269"/>
            <a:ext cx="398456" cy="49975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D5BFA1BA-2C53-4288-94EF-8D33DAA63C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93037" y="597273"/>
            <a:ext cx="398456" cy="4714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8EC72D3E-DE2E-4923-BA32-878E21CD6C9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34714" y="597274"/>
            <a:ext cx="385687" cy="4377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92E85131-C324-4855-84C0-86A8D36DD2B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7470" y="96167"/>
            <a:ext cx="423274" cy="399649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43" name="Group 42">
            <a:extLst>
              <a:ext uri="{FF2B5EF4-FFF2-40B4-BE49-F238E27FC236}">
                <a16:creationId xmlns:a16="http://schemas.microsoft.com/office/drawing/2014/main" id="{3FE86D70-1BCB-4F3F-817A-7624AA38AAF6}"/>
              </a:ext>
            </a:extLst>
          </p:cNvPr>
          <p:cNvGrpSpPr/>
          <p:nvPr/>
        </p:nvGrpSpPr>
        <p:grpSpPr>
          <a:xfrm>
            <a:off x="1105533" y="923548"/>
            <a:ext cx="1730477" cy="688428"/>
            <a:chOff x="3512737" y="1764503"/>
            <a:chExt cx="1730477" cy="688428"/>
          </a:xfrm>
        </p:grpSpPr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4AA18DCA-78AB-4BB0-AFA8-0C6699C801F6}"/>
                </a:ext>
              </a:extLst>
            </p:cNvPr>
            <p:cNvSpPr/>
            <p:nvPr/>
          </p:nvSpPr>
          <p:spPr>
            <a:xfrm>
              <a:off x="3526825" y="1764503"/>
              <a:ext cx="1680420" cy="6323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B8C3920-1C1C-4A8E-B17E-5C7DDE931CDA}"/>
                </a:ext>
              </a:extLst>
            </p:cNvPr>
            <p:cNvSpPr txBox="1"/>
            <p:nvPr/>
          </p:nvSpPr>
          <p:spPr>
            <a:xfrm>
              <a:off x="3512737" y="1806600"/>
              <a:ext cx="173047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llecting </a:t>
              </a:r>
              <a:r>
                <a:rPr lang="en-U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pm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aintainers’ Tweets id</a:t>
              </a:r>
            </a:p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linked with GitHub</a:t>
              </a:r>
            </a:p>
          </p:txBody>
        </p:sp>
      </p:grpSp>
      <p:pic>
        <p:nvPicPr>
          <p:cNvPr id="46" name="Picture 45">
            <a:extLst>
              <a:ext uri="{FF2B5EF4-FFF2-40B4-BE49-F238E27FC236}">
                <a16:creationId xmlns:a16="http://schemas.microsoft.com/office/drawing/2014/main" id="{7BF6DE71-FF83-4DAA-8135-4234012BC2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55914" y="533518"/>
            <a:ext cx="403115" cy="3806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C8A27BCB-93B5-49A5-84EF-2005E87C5D2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57082" y="546995"/>
            <a:ext cx="441354" cy="3651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Arrow: Left-Right 47">
            <a:extLst>
              <a:ext uri="{FF2B5EF4-FFF2-40B4-BE49-F238E27FC236}">
                <a16:creationId xmlns:a16="http://schemas.microsoft.com/office/drawing/2014/main" id="{63ECAC49-32AE-4AFB-BE04-311A68D45166}"/>
              </a:ext>
            </a:extLst>
          </p:cNvPr>
          <p:cNvSpPr/>
          <p:nvPr/>
        </p:nvSpPr>
        <p:spPr>
          <a:xfrm>
            <a:off x="1822953" y="771532"/>
            <a:ext cx="187073" cy="80868"/>
          </a:xfrm>
          <a:prstGeom prst="leftRightArrow">
            <a:avLst/>
          </a:prstGeom>
          <a:solidFill>
            <a:schemeClr val="bg1">
              <a:lumMod val="6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grpSp>
        <p:nvGrpSpPr>
          <p:cNvPr id="49" name="Group 48">
            <a:extLst>
              <a:ext uri="{FF2B5EF4-FFF2-40B4-BE49-F238E27FC236}">
                <a16:creationId xmlns:a16="http://schemas.microsoft.com/office/drawing/2014/main" id="{178EBAB6-65BB-43E4-984D-C74BD4203604}"/>
              </a:ext>
            </a:extLst>
          </p:cNvPr>
          <p:cNvGrpSpPr/>
          <p:nvPr/>
        </p:nvGrpSpPr>
        <p:grpSpPr>
          <a:xfrm>
            <a:off x="122979" y="1383568"/>
            <a:ext cx="722511" cy="891165"/>
            <a:chOff x="2616779" y="1602814"/>
            <a:chExt cx="722511" cy="891165"/>
          </a:xfrm>
        </p:grpSpPr>
        <p:sp>
          <p:nvSpPr>
            <p:cNvPr id="50" name="Flowchart: Magnetic Disk 49">
              <a:extLst>
                <a:ext uri="{FF2B5EF4-FFF2-40B4-BE49-F238E27FC236}">
                  <a16:creationId xmlns:a16="http://schemas.microsoft.com/office/drawing/2014/main" id="{6F4AA27E-7733-43CE-8F1E-DF78C095CED7}"/>
                </a:ext>
              </a:extLst>
            </p:cNvPr>
            <p:cNvSpPr/>
            <p:nvPr/>
          </p:nvSpPr>
          <p:spPr>
            <a:xfrm>
              <a:off x="2616779" y="1602814"/>
              <a:ext cx="716438" cy="891165"/>
            </a:xfrm>
            <a:prstGeom prst="flowChartMagneticDisk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50F47DBD-753B-4216-84AD-609DAE9DD3EB}"/>
                </a:ext>
              </a:extLst>
            </p:cNvPr>
            <p:cNvSpPr txBox="1"/>
            <p:nvPr/>
          </p:nvSpPr>
          <p:spPr>
            <a:xfrm>
              <a:off x="2654487" y="1882217"/>
              <a:ext cx="68480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itHub </a:t>
              </a:r>
            </a:p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taset</a:t>
              </a:r>
            </a:p>
          </p:txBody>
        </p:sp>
      </p:grpSp>
      <p:pic>
        <p:nvPicPr>
          <p:cNvPr id="53" name="Picture 52">
            <a:extLst>
              <a:ext uri="{FF2B5EF4-FFF2-40B4-BE49-F238E27FC236}">
                <a16:creationId xmlns:a16="http://schemas.microsoft.com/office/drawing/2014/main" id="{219A594F-6A56-4D86-A619-2CC9C158B3A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7471" y="1183744"/>
            <a:ext cx="446861" cy="369677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C93741D2-8A72-4D75-B8CC-A15131A3A50D}"/>
              </a:ext>
            </a:extLst>
          </p:cNvPr>
          <p:cNvCxnSpPr>
            <a:cxnSpLocks/>
          </p:cNvCxnSpPr>
          <p:nvPr/>
        </p:nvCxnSpPr>
        <p:spPr>
          <a:xfrm>
            <a:off x="963568" y="1220398"/>
            <a:ext cx="15605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411A3030-6C5B-4EF3-B2C5-8792A03CB905}"/>
              </a:ext>
            </a:extLst>
          </p:cNvPr>
          <p:cNvCxnSpPr/>
          <p:nvPr/>
        </p:nvCxnSpPr>
        <p:spPr>
          <a:xfrm>
            <a:off x="957884" y="713399"/>
            <a:ext cx="0" cy="10972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2607C939-4AD7-4E8A-BCAD-0C0FF5F7DF01}"/>
              </a:ext>
            </a:extLst>
          </p:cNvPr>
          <p:cNvCxnSpPr/>
          <p:nvPr/>
        </p:nvCxnSpPr>
        <p:spPr>
          <a:xfrm>
            <a:off x="833979" y="716241"/>
            <a:ext cx="1198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9A720391-4344-4D1E-A4F4-A061CB065524}"/>
              </a:ext>
            </a:extLst>
          </p:cNvPr>
          <p:cNvCxnSpPr/>
          <p:nvPr/>
        </p:nvCxnSpPr>
        <p:spPr>
          <a:xfrm>
            <a:off x="834409" y="1805424"/>
            <a:ext cx="11981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12303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</TotalTime>
  <Words>38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3</cp:revision>
  <cp:lastPrinted>2023-02-03T06:20:11Z</cp:lastPrinted>
  <dcterms:created xsi:type="dcterms:W3CDTF">2023-01-24T06:46:06Z</dcterms:created>
  <dcterms:modified xsi:type="dcterms:W3CDTF">2023-08-11T14:03:11Z</dcterms:modified>
</cp:coreProperties>
</file>